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06" d="100"/>
          <a:sy n="106" d="100"/>
        </p:scale>
        <p:origin x="-127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40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25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985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729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55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460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332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871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894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9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497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B4B82-9D2C-DE43-8767-B48391B5E649}" type="datetimeFigureOut">
              <a:rPr lang="en-US" smtClean="0"/>
              <a:t>10/2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75A7C-EA05-EF4A-A762-98D46924BF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12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1 - Copy of Best Stim no IL-6_12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856" y="986513"/>
            <a:ext cx="5830316" cy="734923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3182" y="31591"/>
            <a:ext cx="669447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S2 Appendix. </a:t>
            </a:r>
            <a:r>
              <a:rPr lang="en-US" dirty="0" smtClean="0"/>
              <a:t>Data from “normal” </a:t>
            </a:r>
            <a:r>
              <a:rPr lang="en-US" dirty="0" err="1" smtClean="0"/>
              <a:t>timepoints</a:t>
            </a:r>
            <a:r>
              <a:rPr lang="en-US" dirty="0" smtClean="0"/>
              <a:t>, </a:t>
            </a:r>
            <a:r>
              <a:rPr lang="en-US" dirty="0" smtClean="0"/>
              <a:t>grouped by age.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25142" y="82861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870548" y="844007"/>
            <a:ext cx="15873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1α after Con A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2562808" y="82861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864850" y="844007"/>
            <a:ext cx="1475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β after Con A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4476511" y="82861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789985" y="844007"/>
            <a:ext cx="15873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2 after 10 PHA</a:t>
            </a:r>
            <a:endParaRPr lang="en-US" sz="1600" dirty="0"/>
          </a:p>
        </p:txBody>
      </p:sp>
      <p:sp>
        <p:nvSpPr>
          <p:cNvPr id="10" name="TextBox 9"/>
          <p:cNvSpPr txBox="1"/>
          <p:nvPr/>
        </p:nvSpPr>
        <p:spPr>
          <a:xfrm>
            <a:off x="625142" y="2790051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928757" y="2805440"/>
            <a:ext cx="14709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8 after Con A</a:t>
            </a:r>
            <a:endParaRPr lang="en-US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2562808" y="2790051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809145" y="2805440"/>
            <a:ext cx="15873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4 after 10 PHA</a:t>
            </a:r>
            <a:endParaRPr lang="en-US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4476511" y="2790051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725965" y="2805440"/>
            <a:ext cx="17154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FN-</a:t>
            </a:r>
            <a:r>
              <a:rPr lang="en-US" sz="1600" dirty="0" err="1" smtClean="0"/>
              <a:t>γ</a:t>
            </a:r>
            <a:r>
              <a:rPr lang="en-US" sz="1600" dirty="0" smtClean="0"/>
              <a:t> after 10 PHA</a:t>
            </a:r>
            <a:endParaRPr lang="en-US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625142" y="4739503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28119" y="4754892"/>
            <a:ext cx="16722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TNF-α after Con A</a:t>
            </a:r>
            <a:endParaRPr lang="en-US" sz="1600" dirty="0"/>
          </a:p>
        </p:txBody>
      </p:sp>
      <p:sp>
        <p:nvSpPr>
          <p:cNvPr id="18" name="TextBox 17"/>
          <p:cNvSpPr txBox="1"/>
          <p:nvPr/>
        </p:nvSpPr>
        <p:spPr>
          <a:xfrm>
            <a:off x="2562808" y="4739503"/>
            <a:ext cx="328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2837248" y="4754892"/>
            <a:ext cx="1531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18 after </a:t>
            </a:r>
            <a:r>
              <a:rPr lang="en-US" sz="1600" dirty="0" err="1" smtClean="0"/>
              <a:t>ConA</a:t>
            </a:r>
            <a:endParaRPr lang="en-US" sz="1600" dirty="0"/>
          </a:p>
        </p:txBody>
      </p:sp>
      <p:sp>
        <p:nvSpPr>
          <p:cNvPr id="20" name="TextBox 19"/>
          <p:cNvSpPr txBox="1"/>
          <p:nvPr/>
        </p:nvSpPr>
        <p:spPr>
          <a:xfrm>
            <a:off x="4476511" y="4739503"/>
            <a:ext cx="242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4674920" y="4754892"/>
            <a:ext cx="18175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1RA after 10 PHA</a:t>
            </a:r>
            <a:endParaRPr lang="en-US" sz="1600" dirty="0"/>
          </a:p>
        </p:txBody>
      </p:sp>
      <p:sp>
        <p:nvSpPr>
          <p:cNvPr id="22" name="TextBox 21"/>
          <p:cNvSpPr txBox="1"/>
          <p:nvPr/>
        </p:nvSpPr>
        <p:spPr>
          <a:xfrm>
            <a:off x="1712050" y="6605093"/>
            <a:ext cx="258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J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1915027" y="6620482"/>
            <a:ext cx="1691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13 after 10 PHA</a:t>
            </a:r>
            <a:endParaRPr lang="en-US" sz="1600" dirty="0"/>
          </a:p>
        </p:txBody>
      </p:sp>
      <p:sp>
        <p:nvSpPr>
          <p:cNvPr id="24" name="TextBox 23"/>
          <p:cNvSpPr txBox="1"/>
          <p:nvPr/>
        </p:nvSpPr>
        <p:spPr>
          <a:xfrm>
            <a:off x="3649716" y="6605093"/>
            <a:ext cx="304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3908035" y="6620482"/>
            <a:ext cx="1691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L-10 after 10 PHA</a:t>
            </a:r>
            <a:endParaRPr lang="en-US" sz="1600" dirty="0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3"/>
          <a:srcRect l="49712" t="6979" r="39318" b="67248"/>
          <a:stretch/>
        </p:blipFill>
        <p:spPr>
          <a:xfrm>
            <a:off x="5547294" y="7169825"/>
            <a:ext cx="299540" cy="533537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5696228" y="7169825"/>
            <a:ext cx="561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Older</a:t>
            </a:r>
            <a:endParaRPr lang="en-US" sz="1200" dirty="0"/>
          </a:p>
        </p:txBody>
      </p:sp>
      <p:sp>
        <p:nvSpPr>
          <p:cNvPr id="33" name="TextBox 32"/>
          <p:cNvSpPr txBox="1"/>
          <p:nvPr/>
        </p:nvSpPr>
        <p:spPr>
          <a:xfrm>
            <a:off x="5696228" y="7394107"/>
            <a:ext cx="761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Younger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10212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2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RS/USD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elia Hofstetter</dc:creator>
  <cp:lastModifiedBy>Amelia Hofstetter</cp:lastModifiedBy>
  <cp:revision>2</cp:revision>
  <dcterms:created xsi:type="dcterms:W3CDTF">2017-10-23T16:11:03Z</dcterms:created>
  <dcterms:modified xsi:type="dcterms:W3CDTF">2017-10-23T16:12:43Z</dcterms:modified>
</cp:coreProperties>
</file>